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924" r:id="rId1"/>
  </p:sldMasterIdLst>
  <p:sldIdLst>
    <p:sldId id="260" r:id="rId2"/>
  </p:sldIdLst>
  <p:sldSz cx="32399288" cy="51120675"/>
  <p:notesSz cx="6858000" cy="9144000"/>
  <p:defaultTextStyle>
    <a:defPPr>
      <a:defRPr lang="en-US"/>
    </a:defPPr>
    <a:lvl1pPr marL="0" algn="l" defTabSz="3583394" rtl="0" eaLnBrk="1" latinLnBrk="0" hangingPunct="1">
      <a:defRPr sz="7055" kern="1200">
        <a:solidFill>
          <a:schemeClr val="tx1"/>
        </a:solidFill>
        <a:latin typeface="+mn-lt"/>
        <a:ea typeface="+mn-ea"/>
        <a:cs typeface="+mn-cs"/>
      </a:defRPr>
    </a:lvl1pPr>
    <a:lvl2pPr marL="1791698" algn="l" defTabSz="3583394" rtl="0" eaLnBrk="1" latinLnBrk="0" hangingPunct="1">
      <a:defRPr sz="7055" kern="1200">
        <a:solidFill>
          <a:schemeClr val="tx1"/>
        </a:solidFill>
        <a:latin typeface="+mn-lt"/>
        <a:ea typeface="+mn-ea"/>
        <a:cs typeface="+mn-cs"/>
      </a:defRPr>
    </a:lvl2pPr>
    <a:lvl3pPr marL="3583394" algn="l" defTabSz="3583394" rtl="0" eaLnBrk="1" latinLnBrk="0" hangingPunct="1">
      <a:defRPr sz="7055" kern="1200">
        <a:solidFill>
          <a:schemeClr val="tx1"/>
        </a:solidFill>
        <a:latin typeface="+mn-lt"/>
        <a:ea typeface="+mn-ea"/>
        <a:cs typeface="+mn-cs"/>
      </a:defRPr>
    </a:lvl3pPr>
    <a:lvl4pPr marL="5375091" algn="l" defTabSz="3583394" rtl="0" eaLnBrk="1" latinLnBrk="0" hangingPunct="1">
      <a:defRPr sz="7055" kern="1200">
        <a:solidFill>
          <a:schemeClr val="tx1"/>
        </a:solidFill>
        <a:latin typeface="+mn-lt"/>
        <a:ea typeface="+mn-ea"/>
        <a:cs typeface="+mn-cs"/>
      </a:defRPr>
    </a:lvl4pPr>
    <a:lvl5pPr marL="7166782" algn="l" defTabSz="3583394" rtl="0" eaLnBrk="1" latinLnBrk="0" hangingPunct="1">
      <a:defRPr sz="7055" kern="1200">
        <a:solidFill>
          <a:schemeClr val="tx1"/>
        </a:solidFill>
        <a:latin typeface="+mn-lt"/>
        <a:ea typeface="+mn-ea"/>
        <a:cs typeface="+mn-cs"/>
      </a:defRPr>
    </a:lvl5pPr>
    <a:lvl6pPr marL="8958484" algn="l" defTabSz="3583394" rtl="0" eaLnBrk="1" latinLnBrk="0" hangingPunct="1">
      <a:defRPr sz="7055" kern="1200">
        <a:solidFill>
          <a:schemeClr val="tx1"/>
        </a:solidFill>
        <a:latin typeface="+mn-lt"/>
        <a:ea typeface="+mn-ea"/>
        <a:cs typeface="+mn-cs"/>
      </a:defRPr>
    </a:lvl6pPr>
    <a:lvl7pPr marL="10750181" algn="l" defTabSz="3583394" rtl="0" eaLnBrk="1" latinLnBrk="0" hangingPunct="1">
      <a:defRPr sz="7055" kern="1200">
        <a:solidFill>
          <a:schemeClr val="tx1"/>
        </a:solidFill>
        <a:latin typeface="+mn-lt"/>
        <a:ea typeface="+mn-ea"/>
        <a:cs typeface="+mn-cs"/>
      </a:defRPr>
    </a:lvl7pPr>
    <a:lvl8pPr marL="12541873" algn="l" defTabSz="3583394" rtl="0" eaLnBrk="1" latinLnBrk="0" hangingPunct="1">
      <a:defRPr sz="7055" kern="1200">
        <a:solidFill>
          <a:schemeClr val="tx1"/>
        </a:solidFill>
        <a:latin typeface="+mn-lt"/>
        <a:ea typeface="+mn-ea"/>
        <a:cs typeface="+mn-cs"/>
      </a:defRPr>
    </a:lvl8pPr>
    <a:lvl9pPr marL="14333573" algn="l" defTabSz="3583394" rtl="0" eaLnBrk="1" latinLnBrk="0" hangingPunct="1">
      <a:defRPr sz="7055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6110" userDrawn="1">
          <p15:clr>
            <a:srgbClr val="A4A3A4"/>
          </p15:clr>
        </p15:guide>
        <p15:guide id="2" pos="10209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9900"/>
    <a:srgbClr val="3333FF"/>
    <a:srgbClr val="996600"/>
    <a:srgbClr val="FF00FF"/>
    <a:srgbClr val="A50021"/>
    <a:srgbClr val="99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711" autoAdjust="0"/>
  </p:normalViewPr>
  <p:slideViewPr>
    <p:cSldViewPr snapToGrid="0" showGuides="1">
      <p:cViewPr varScale="1">
        <p:scale>
          <a:sx n="10" d="100"/>
          <a:sy n="10" d="100"/>
        </p:scale>
        <p:origin x="1692" y="24"/>
      </p:cViewPr>
      <p:guideLst>
        <p:guide orient="horz" pos="16110"/>
        <p:guide pos="10209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429947" y="8366281"/>
            <a:ext cx="27539395" cy="17797568"/>
          </a:xfrm>
        </p:spPr>
        <p:txBody>
          <a:bodyPr anchor="b"/>
          <a:lstStyle>
            <a:lvl1pPr algn="ctr">
              <a:defRPr sz="21259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4049911" y="26850192"/>
            <a:ext cx="24299466" cy="12342326"/>
          </a:xfrm>
        </p:spPr>
        <p:txBody>
          <a:bodyPr/>
          <a:lstStyle>
            <a:lvl1pPr marL="0" indent="0" algn="ctr">
              <a:buNone/>
              <a:defRPr sz="8504"/>
            </a:lvl1pPr>
            <a:lvl2pPr marL="1619951" indent="0" algn="ctr">
              <a:buNone/>
              <a:defRPr sz="7086"/>
            </a:lvl2pPr>
            <a:lvl3pPr marL="3239902" indent="0" algn="ctr">
              <a:buNone/>
              <a:defRPr sz="6378"/>
            </a:lvl3pPr>
            <a:lvl4pPr marL="4859853" indent="0" algn="ctr">
              <a:buNone/>
              <a:defRPr sz="5669"/>
            </a:lvl4pPr>
            <a:lvl5pPr marL="6479804" indent="0" algn="ctr">
              <a:buNone/>
              <a:defRPr sz="5669"/>
            </a:lvl5pPr>
            <a:lvl6pPr marL="8099755" indent="0" algn="ctr">
              <a:buNone/>
              <a:defRPr sz="5669"/>
            </a:lvl6pPr>
            <a:lvl7pPr marL="9719706" indent="0" algn="ctr">
              <a:buNone/>
              <a:defRPr sz="5669"/>
            </a:lvl7pPr>
            <a:lvl8pPr marL="11339657" indent="0" algn="ctr">
              <a:buNone/>
              <a:defRPr sz="5669"/>
            </a:lvl8pPr>
            <a:lvl9pPr marL="12959608" indent="0" algn="ctr">
              <a:buNone/>
              <a:defRPr sz="5669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977394-CCC5-4E93-9C75-5CA81DB11201}" type="datetimeFigureOut">
              <a:rPr lang="en-US" smtClean="0"/>
              <a:t>2/1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864327-EEAC-45A3-B1B5-A566D2C958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80869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977394-CCC5-4E93-9C75-5CA81DB11201}" type="datetimeFigureOut">
              <a:rPr lang="en-US" smtClean="0"/>
              <a:t>2/1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864327-EEAC-45A3-B1B5-A566D2C958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72435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3185742" y="2721703"/>
            <a:ext cx="6986096" cy="43322409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227453" y="2721703"/>
            <a:ext cx="20553298" cy="43322409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977394-CCC5-4E93-9C75-5CA81DB11201}" type="datetimeFigureOut">
              <a:rPr lang="en-US" smtClean="0"/>
              <a:t>2/1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864327-EEAC-45A3-B1B5-A566D2C958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25205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977394-CCC5-4E93-9C75-5CA81DB11201}" type="datetimeFigureOut">
              <a:rPr lang="en-US" smtClean="0"/>
              <a:t>2/1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864327-EEAC-45A3-B1B5-A566D2C958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56687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210578" y="12744683"/>
            <a:ext cx="27944386" cy="21264777"/>
          </a:xfrm>
        </p:spPr>
        <p:txBody>
          <a:bodyPr anchor="b"/>
          <a:lstStyle>
            <a:lvl1pPr>
              <a:defRPr sz="21259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210578" y="34210633"/>
            <a:ext cx="27944386" cy="11182644"/>
          </a:xfrm>
        </p:spPr>
        <p:txBody>
          <a:bodyPr/>
          <a:lstStyle>
            <a:lvl1pPr marL="0" indent="0">
              <a:buNone/>
              <a:defRPr sz="8504">
                <a:solidFill>
                  <a:schemeClr val="tx1"/>
                </a:solidFill>
              </a:defRPr>
            </a:lvl1pPr>
            <a:lvl2pPr marL="1619951" indent="0">
              <a:buNone/>
              <a:defRPr sz="7086">
                <a:solidFill>
                  <a:schemeClr val="tx1">
                    <a:tint val="75000"/>
                  </a:schemeClr>
                </a:solidFill>
              </a:defRPr>
            </a:lvl2pPr>
            <a:lvl3pPr marL="3239902" indent="0">
              <a:buNone/>
              <a:defRPr sz="6378">
                <a:solidFill>
                  <a:schemeClr val="tx1">
                    <a:tint val="75000"/>
                  </a:schemeClr>
                </a:solidFill>
              </a:defRPr>
            </a:lvl3pPr>
            <a:lvl4pPr marL="4859853" indent="0">
              <a:buNone/>
              <a:defRPr sz="5669">
                <a:solidFill>
                  <a:schemeClr val="tx1">
                    <a:tint val="75000"/>
                  </a:schemeClr>
                </a:solidFill>
              </a:defRPr>
            </a:lvl4pPr>
            <a:lvl5pPr marL="6479804" indent="0">
              <a:buNone/>
              <a:defRPr sz="5669">
                <a:solidFill>
                  <a:schemeClr val="tx1">
                    <a:tint val="75000"/>
                  </a:schemeClr>
                </a:solidFill>
              </a:defRPr>
            </a:lvl5pPr>
            <a:lvl6pPr marL="8099755" indent="0">
              <a:buNone/>
              <a:defRPr sz="5669">
                <a:solidFill>
                  <a:schemeClr val="tx1">
                    <a:tint val="75000"/>
                  </a:schemeClr>
                </a:solidFill>
              </a:defRPr>
            </a:lvl6pPr>
            <a:lvl7pPr marL="9719706" indent="0">
              <a:buNone/>
              <a:defRPr sz="5669">
                <a:solidFill>
                  <a:schemeClr val="tx1">
                    <a:tint val="75000"/>
                  </a:schemeClr>
                </a:solidFill>
              </a:defRPr>
            </a:lvl7pPr>
            <a:lvl8pPr marL="11339657" indent="0">
              <a:buNone/>
              <a:defRPr sz="5669">
                <a:solidFill>
                  <a:schemeClr val="tx1">
                    <a:tint val="75000"/>
                  </a:schemeClr>
                </a:solidFill>
              </a:defRPr>
            </a:lvl8pPr>
            <a:lvl9pPr marL="12959608" indent="0">
              <a:buNone/>
              <a:defRPr sz="5669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977394-CCC5-4E93-9C75-5CA81DB11201}" type="datetimeFigureOut">
              <a:rPr lang="en-US" smtClean="0"/>
              <a:t>2/1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864327-EEAC-45A3-B1B5-A566D2C958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22456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227451" y="13608513"/>
            <a:ext cx="13769697" cy="3243559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6402140" y="13608513"/>
            <a:ext cx="13769697" cy="3243559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977394-CCC5-4E93-9C75-5CA81DB11201}" type="datetimeFigureOut">
              <a:rPr lang="en-US" smtClean="0"/>
              <a:t>2/16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864327-EEAC-45A3-B1B5-A566D2C958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98827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231671" y="2721714"/>
            <a:ext cx="27944386" cy="9880968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231675" y="12531669"/>
            <a:ext cx="13706415" cy="6141577"/>
          </a:xfrm>
        </p:spPr>
        <p:txBody>
          <a:bodyPr anchor="b"/>
          <a:lstStyle>
            <a:lvl1pPr marL="0" indent="0">
              <a:buNone/>
              <a:defRPr sz="8504" b="1"/>
            </a:lvl1pPr>
            <a:lvl2pPr marL="1619951" indent="0">
              <a:buNone/>
              <a:defRPr sz="7086" b="1"/>
            </a:lvl2pPr>
            <a:lvl3pPr marL="3239902" indent="0">
              <a:buNone/>
              <a:defRPr sz="6378" b="1"/>
            </a:lvl3pPr>
            <a:lvl4pPr marL="4859853" indent="0">
              <a:buNone/>
              <a:defRPr sz="5669" b="1"/>
            </a:lvl4pPr>
            <a:lvl5pPr marL="6479804" indent="0">
              <a:buNone/>
              <a:defRPr sz="5669" b="1"/>
            </a:lvl5pPr>
            <a:lvl6pPr marL="8099755" indent="0">
              <a:buNone/>
              <a:defRPr sz="5669" b="1"/>
            </a:lvl6pPr>
            <a:lvl7pPr marL="9719706" indent="0">
              <a:buNone/>
              <a:defRPr sz="5669" b="1"/>
            </a:lvl7pPr>
            <a:lvl8pPr marL="11339657" indent="0">
              <a:buNone/>
              <a:defRPr sz="5669" b="1"/>
            </a:lvl8pPr>
            <a:lvl9pPr marL="12959608" indent="0">
              <a:buNone/>
              <a:defRPr sz="5669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231675" y="18673247"/>
            <a:ext cx="13706415" cy="2746553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6402142" y="12531669"/>
            <a:ext cx="13773917" cy="6141577"/>
          </a:xfrm>
        </p:spPr>
        <p:txBody>
          <a:bodyPr anchor="b"/>
          <a:lstStyle>
            <a:lvl1pPr marL="0" indent="0">
              <a:buNone/>
              <a:defRPr sz="8504" b="1"/>
            </a:lvl1pPr>
            <a:lvl2pPr marL="1619951" indent="0">
              <a:buNone/>
              <a:defRPr sz="7086" b="1"/>
            </a:lvl2pPr>
            <a:lvl3pPr marL="3239902" indent="0">
              <a:buNone/>
              <a:defRPr sz="6378" b="1"/>
            </a:lvl3pPr>
            <a:lvl4pPr marL="4859853" indent="0">
              <a:buNone/>
              <a:defRPr sz="5669" b="1"/>
            </a:lvl4pPr>
            <a:lvl5pPr marL="6479804" indent="0">
              <a:buNone/>
              <a:defRPr sz="5669" b="1"/>
            </a:lvl5pPr>
            <a:lvl6pPr marL="8099755" indent="0">
              <a:buNone/>
              <a:defRPr sz="5669" b="1"/>
            </a:lvl6pPr>
            <a:lvl7pPr marL="9719706" indent="0">
              <a:buNone/>
              <a:defRPr sz="5669" b="1"/>
            </a:lvl7pPr>
            <a:lvl8pPr marL="11339657" indent="0">
              <a:buNone/>
              <a:defRPr sz="5669" b="1"/>
            </a:lvl8pPr>
            <a:lvl9pPr marL="12959608" indent="0">
              <a:buNone/>
              <a:defRPr sz="5669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6402142" y="18673247"/>
            <a:ext cx="13773917" cy="2746553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977394-CCC5-4E93-9C75-5CA81DB11201}" type="datetimeFigureOut">
              <a:rPr lang="en-US" smtClean="0"/>
              <a:t>2/16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864327-EEAC-45A3-B1B5-A566D2C958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21285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977394-CCC5-4E93-9C75-5CA81DB11201}" type="datetimeFigureOut">
              <a:rPr lang="en-US" smtClean="0"/>
              <a:t>2/16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864327-EEAC-45A3-B1B5-A566D2C958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67762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977394-CCC5-4E93-9C75-5CA81DB11201}" type="datetimeFigureOut">
              <a:rPr lang="en-US" smtClean="0"/>
              <a:t>2/16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864327-EEAC-45A3-B1B5-A566D2C958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07281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231671" y="3408045"/>
            <a:ext cx="10449614" cy="11928158"/>
          </a:xfrm>
        </p:spPr>
        <p:txBody>
          <a:bodyPr anchor="b"/>
          <a:lstStyle>
            <a:lvl1pPr>
              <a:defRPr sz="11338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3773917" y="7360442"/>
            <a:ext cx="16402140" cy="36328813"/>
          </a:xfrm>
        </p:spPr>
        <p:txBody>
          <a:bodyPr/>
          <a:lstStyle>
            <a:lvl1pPr>
              <a:defRPr sz="11338"/>
            </a:lvl1pPr>
            <a:lvl2pPr>
              <a:defRPr sz="9921"/>
            </a:lvl2pPr>
            <a:lvl3pPr>
              <a:defRPr sz="8504"/>
            </a:lvl3pPr>
            <a:lvl4pPr>
              <a:defRPr sz="7086"/>
            </a:lvl4pPr>
            <a:lvl5pPr>
              <a:defRPr sz="7086"/>
            </a:lvl5pPr>
            <a:lvl6pPr>
              <a:defRPr sz="7086"/>
            </a:lvl6pPr>
            <a:lvl7pPr>
              <a:defRPr sz="7086"/>
            </a:lvl7pPr>
            <a:lvl8pPr>
              <a:defRPr sz="7086"/>
            </a:lvl8pPr>
            <a:lvl9pPr>
              <a:defRPr sz="7086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231671" y="15336203"/>
            <a:ext cx="10449614" cy="28412212"/>
          </a:xfrm>
        </p:spPr>
        <p:txBody>
          <a:bodyPr/>
          <a:lstStyle>
            <a:lvl1pPr marL="0" indent="0">
              <a:buNone/>
              <a:defRPr sz="5669"/>
            </a:lvl1pPr>
            <a:lvl2pPr marL="1619951" indent="0">
              <a:buNone/>
              <a:defRPr sz="4960"/>
            </a:lvl2pPr>
            <a:lvl3pPr marL="3239902" indent="0">
              <a:buNone/>
              <a:defRPr sz="4252"/>
            </a:lvl3pPr>
            <a:lvl4pPr marL="4859853" indent="0">
              <a:buNone/>
              <a:defRPr sz="3543"/>
            </a:lvl4pPr>
            <a:lvl5pPr marL="6479804" indent="0">
              <a:buNone/>
              <a:defRPr sz="3543"/>
            </a:lvl5pPr>
            <a:lvl6pPr marL="8099755" indent="0">
              <a:buNone/>
              <a:defRPr sz="3543"/>
            </a:lvl6pPr>
            <a:lvl7pPr marL="9719706" indent="0">
              <a:buNone/>
              <a:defRPr sz="3543"/>
            </a:lvl7pPr>
            <a:lvl8pPr marL="11339657" indent="0">
              <a:buNone/>
              <a:defRPr sz="3543"/>
            </a:lvl8pPr>
            <a:lvl9pPr marL="12959608" indent="0">
              <a:buNone/>
              <a:defRPr sz="3543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977394-CCC5-4E93-9C75-5CA81DB11201}" type="datetimeFigureOut">
              <a:rPr lang="en-US" smtClean="0"/>
              <a:t>2/16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864327-EEAC-45A3-B1B5-A566D2C958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92820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231671" y="3408045"/>
            <a:ext cx="10449614" cy="11928158"/>
          </a:xfrm>
        </p:spPr>
        <p:txBody>
          <a:bodyPr anchor="b"/>
          <a:lstStyle>
            <a:lvl1pPr>
              <a:defRPr sz="11338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3773917" y="7360442"/>
            <a:ext cx="16402140" cy="36328813"/>
          </a:xfrm>
        </p:spPr>
        <p:txBody>
          <a:bodyPr anchor="t"/>
          <a:lstStyle>
            <a:lvl1pPr marL="0" indent="0">
              <a:buNone/>
              <a:defRPr sz="11338"/>
            </a:lvl1pPr>
            <a:lvl2pPr marL="1619951" indent="0">
              <a:buNone/>
              <a:defRPr sz="9921"/>
            </a:lvl2pPr>
            <a:lvl3pPr marL="3239902" indent="0">
              <a:buNone/>
              <a:defRPr sz="8504"/>
            </a:lvl3pPr>
            <a:lvl4pPr marL="4859853" indent="0">
              <a:buNone/>
              <a:defRPr sz="7086"/>
            </a:lvl4pPr>
            <a:lvl5pPr marL="6479804" indent="0">
              <a:buNone/>
              <a:defRPr sz="7086"/>
            </a:lvl5pPr>
            <a:lvl6pPr marL="8099755" indent="0">
              <a:buNone/>
              <a:defRPr sz="7086"/>
            </a:lvl6pPr>
            <a:lvl7pPr marL="9719706" indent="0">
              <a:buNone/>
              <a:defRPr sz="7086"/>
            </a:lvl7pPr>
            <a:lvl8pPr marL="11339657" indent="0">
              <a:buNone/>
              <a:defRPr sz="7086"/>
            </a:lvl8pPr>
            <a:lvl9pPr marL="12959608" indent="0">
              <a:buNone/>
              <a:defRPr sz="7086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231671" y="15336203"/>
            <a:ext cx="10449614" cy="28412212"/>
          </a:xfrm>
        </p:spPr>
        <p:txBody>
          <a:bodyPr/>
          <a:lstStyle>
            <a:lvl1pPr marL="0" indent="0">
              <a:buNone/>
              <a:defRPr sz="5669"/>
            </a:lvl1pPr>
            <a:lvl2pPr marL="1619951" indent="0">
              <a:buNone/>
              <a:defRPr sz="4960"/>
            </a:lvl2pPr>
            <a:lvl3pPr marL="3239902" indent="0">
              <a:buNone/>
              <a:defRPr sz="4252"/>
            </a:lvl3pPr>
            <a:lvl4pPr marL="4859853" indent="0">
              <a:buNone/>
              <a:defRPr sz="3543"/>
            </a:lvl4pPr>
            <a:lvl5pPr marL="6479804" indent="0">
              <a:buNone/>
              <a:defRPr sz="3543"/>
            </a:lvl5pPr>
            <a:lvl6pPr marL="8099755" indent="0">
              <a:buNone/>
              <a:defRPr sz="3543"/>
            </a:lvl6pPr>
            <a:lvl7pPr marL="9719706" indent="0">
              <a:buNone/>
              <a:defRPr sz="3543"/>
            </a:lvl7pPr>
            <a:lvl8pPr marL="11339657" indent="0">
              <a:buNone/>
              <a:defRPr sz="3543"/>
            </a:lvl8pPr>
            <a:lvl9pPr marL="12959608" indent="0">
              <a:buNone/>
              <a:defRPr sz="3543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977394-CCC5-4E93-9C75-5CA81DB11201}" type="datetimeFigureOut">
              <a:rPr lang="en-US" smtClean="0"/>
              <a:t>2/16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864327-EEAC-45A3-B1B5-A566D2C958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16843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227451" y="2721714"/>
            <a:ext cx="27944386" cy="988096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227451" y="13608513"/>
            <a:ext cx="27944386" cy="3243559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227451" y="47381303"/>
            <a:ext cx="7289840" cy="27217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425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977394-CCC5-4E93-9C75-5CA81DB11201}" type="datetimeFigureOut">
              <a:rPr lang="en-US" smtClean="0"/>
              <a:t>2/1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0732264" y="47381303"/>
            <a:ext cx="10934760" cy="27217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425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22881997" y="47381303"/>
            <a:ext cx="7289840" cy="27217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425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864327-EEAC-45A3-B1B5-A566D2C958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23713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925" r:id="rId1"/>
    <p:sldLayoutId id="2147483926" r:id="rId2"/>
    <p:sldLayoutId id="2147483927" r:id="rId3"/>
    <p:sldLayoutId id="2147483928" r:id="rId4"/>
    <p:sldLayoutId id="2147483929" r:id="rId5"/>
    <p:sldLayoutId id="2147483930" r:id="rId6"/>
    <p:sldLayoutId id="2147483931" r:id="rId7"/>
    <p:sldLayoutId id="2147483932" r:id="rId8"/>
    <p:sldLayoutId id="2147483933" r:id="rId9"/>
    <p:sldLayoutId id="2147483934" r:id="rId10"/>
    <p:sldLayoutId id="2147483935" r:id="rId11"/>
  </p:sldLayoutIdLst>
  <p:txStyles>
    <p:titleStyle>
      <a:lvl1pPr algn="l" defTabSz="3239902" rtl="0" eaLnBrk="1" latinLnBrk="0" hangingPunct="1">
        <a:lnSpc>
          <a:spcPct val="90000"/>
        </a:lnSpc>
        <a:spcBef>
          <a:spcPct val="0"/>
        </a:spcBef>
        <a:buNone/>
        <a:defRPr sz="1559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809976" indent="-809976" algn="l" defTabSz="3239902" rtl="0" eaLnBrk="1" latinLnBrk="0" hangingPunct="1">
        <a:lnSpc>
          <a:spcPct val="90000"/>
        </a:lnSpc>
        <a:spcBef>
          <a:spcPts val="3543"/>
        </a:spcBef>
        <a:buFont typeface="Arial" panose="020B0604020202020204" pitchFamily="34" charset="0"/>
        <a:buChar char="•"/>
        <a:defRPr sz="9921" kern="1200">
          <a:solidFill>
            <a:schemeClr val="tx1"/>
          </a:solidFill>
          <a:latin typeface="+mn-lt"/>
          <a:ea typeface="+mn-ea"/>
          <a:cs typeface="+mn-cs"/>
        </a:defRPr>
      </a:lvl1pPr>
      <a:lvl2pPr marL="2429927" indent="-809976" algn="l" defTabSz="3239902" rtl="0" eaLnBrk="1" latinLnBrk="0" hangingPunct="1">
        <a:lnSpc>
          <a:spcPct val="90000"/>
        </a:lnSpc>
        <a:spcBef>
          <a:spcPts val="1772"/>
        </a:spcBef>
        <a:buFont typeface="Arial" panose="020B0604020202020204" pitchFamily="34" charset="0"/>
        <a:buChar char="•"/>
        <a:defRPr sz="8504" kern="1200">
          <a:solidFill>
            <a:schemeClr val="tx1"/>
          </a:solidFill>
          <a:latin typeface="+mn-lt"/>
          <a:ea typeface="+mn-ea"/>
          <a:cs typeface="+mn-cs"/>
        </a:defRPr>
      </a:lvl2pPr>
      <a:lvl3pPr marL="4049878" indent="-809976" algn="l" defTabSz="3239902" rtl="0" eaLnBrk="1" latinLnBrk="0" hangingPunct="1">
        <a:lnSpc>
          <a:spcPct val="90000"/>
        </a:lnSpc>
        <a:spcBef>
          <a:spcPts val="1772"/>
        </a:spcBef>
        <a:buFont typeface="Arial" panose="020B0604020202020204" pitchFamily="34" charset="0"/>
        <a:buChar char="•"/>
        <a:defRPr sz="7086" kern="1200">
          <a:solidFill>
            <a:schemeClr val="tx1"/>
          </a:solidFill>
          <a:latin typeface="+mn-lt"/>
          <a:ea typeface="+mn-ea"/>
          <a:cs typeface="+mn-cs"/>
        </a:defRPr>
      </a:lvl3pPr>
      <a:lvl4pPr marL="5669829" indent="-809976" algn="l" defTabSz="3239902" rtl="0" eaLnBrk="1" latinLnBrk="0" hangingPunct="1">
        <a:lnSpc>
          <a:spcPct val="90000"/>
        </a:lnSpc>
        <a:spcBef>
          <a:spcPts val="1772"/>
        </a:spcBef>
        <a:buFont typeface="Arial" panose="020B0604020202020204" pitchFamily="34" charset="0"/>
        <a:buChar char="•"/>
        <a:defRPr sz="6378" kern="1200">
          <a:solidFill>
            <a:schemeClr val="tx1"/>
          </a:solidFill>
          <a:latin typeface="+mn-lt"/>
          <a:ea typeface="+mn-ea"/>
          <a:cs typeface="+mn-cs"/>
        </a:defRPr>
      </a:lvl4pPr>
      <a:lvl5pPr marL="7289780" indent="-809976" algn="l" defTabSz="3239902" rtl="0" eaLnBrk="1" latinLnBrk="0" hangingPunct="1">
        <a:lnSpc>
          <a:spcPct val="90000"/>
        </a:lnSpc>
        <a:spcBef>
          <a:spcPts val="1772"/>
        </a:spcBef>
        <a:buFont typeface="Arial" panose="020B0604020202020204" pitchFamily="34" charset="0"/>
        <a:buChar char="•"/>
        <a:defRPr sz="6378" kern="1200">
          <a:solidFill>
            <a:schemeClr val="tx1"/>
          </a:solidFill>
          <a:latin typeface="+mn-lt"/>
          <a:ea typeface="+mn-ea"/>
          <a:cs typeface="+mn-cs"/>
        </a:defRPr>
      </a:lvl5pPr>
      <a:lvl6pPr marL="8909731" indent="-809976" algn="l" defTabSz="3239902" rtl="0" eaLnBrk="1" latinLnBrk="0" hangingPunct="1">
        <a:lnSpc>
          <a:spcPct val="90000"/>
        </a:lnSpc>
        <a:spcBef>
          <a:spcPts val="1772"/>
        </a:spcBef>
        <a:buFont typeface="Arial" panose="020B0604020202020204" pitchFamily="34" charset="0"/>
        <a:buChar char="•"/>
        <a:defRPr sz="6378" kern="1200">
          <a:solidFill>
            <a:schemeClr val="tx1"/>
          </a:solidFill>
          <a:latin typeface="+mn-lt"/>
          <a:ea typeface="+mn-ea"/>
          <a:cs typeface="+mn-cs"/>
        </a:defRPr>
      </a:lvl6pPr>
      <a:lvl7pPr marL="10529682" indent="-809976" algn="l" defTabSz="3239902" rtl="0" eaLnBrk="1" latinLnBrk="0" hangingPunct="1">
        <a:lnSpc>
          <a:spcPct val="90000"/>
        </a:lnSpc>
        <a:spcBef>
          <a:spcPts val="1772"/>
        </a:spcBef>
        <a:buFont typeface="Arial" panose="020B0604020202020204" pitchFamily="34" charset="0"/>
        <a:buChar char="•"/>
        <a:defRPr sz="6378" kern="1200">
          <a:solidFill>
            <a:schemeClr val="tx1"/>
          </a:solidFill>
          <a:latin typeface="+mn-lt"/>
          <a:ea typeface="+mn-ea"/>
          <a:cs typeface="+mn-cs"/>
        </a:defRPr>
      </a:lvl7pPr>
      <a:lvl8pPr marL="12149633" indent="-809976" algn="l" defTabSz="3239902" rtl="0" eaLnBrk="1" latinLnBrk="0" hangingPunct="1">
        <a:lnSpc>
          <a:spcPct val="90000"/>
        </a:lnSpc>
        <a:spcBef>
          <a:spcPts val="1772"/>
        </a:spcBef>
        <a:buFont typeface="Arial" panose="020B0604020202020204" pitchFamily="34" charset="0"/>
        <a:buChar char="•"/>
        <a:defRPr sz="6378" kern="1200">
          <a:solidFill>
            <a:schemeClr val="tx1"/>
          </a:solidFill>
          <a:latin typeface="+mn-lt"/>
          <a:ea typeface="+mn-ea"/>
          <a:cs typeface="+mn-cs"/>
        </a:defRPr>
      </a:lvl8pPr>
      <a:lvl9pPr marL="13769584" indent="-809976" algn="l" defTabSz="3239902" rtl="0" eaLnBrk="1" latinLnBrk="0" hangingPunct="1">
        <a:lnSpc>
          <a:spcPct val="90000"/>
        </a:lnSpc>
        <a:spcBef>
          <a:spcPts val="1772"/>
        </a:spcBef>
        <a:buFont typeface="Arial" panose="020B0604020202020204" pitchFamily="34" charset="0"/>
        <a:buChar char="•"/>
        <a:defRPr sz="637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239902" rtl="0" eaLnBrk="1" latinLnBrk="0" hangingPunct="1">
        <a:defRPr sz="6378" kern="1200">
          <a:solidFill>
            <a:schemeClr val="tx1"/>
          </a:solidFill>
          <a:latin typeface="+mn-lt"/>
          <a:ea typeface="+mn-ea"/>
          <a:cs typeface="+mn-cs"/>
        </a:defRPr>
      </a:lvl1pPr>
      <a:lvl2pPr marL="1619951" algn="l" defTabSz="3239902" rtl="0" eaLnBrk="1" latinLnBrk="0" hangingPunct="1">
        <a:defRPr sz="6378" kern="1200">
          <a:solidFill>
            <a:schemeClr val="tx1"/>
          </a:solidFill>
          <a:latin typeface="+mn-lt"/>
          <a:ea typeface="+mn-ea"/>
          <a:cs typeface="+mn-cs"/>
        </a:defRPr>
      </a:lvl2pPr>
      <a:lvl3pPr marL="3239902" algn="l" defTabSz="3239902" rtl="0" eaLnBrk="1" latinLnBrk="0" hangingPunct="1">
        <a:defRPr sz="6378" kern="1200">
          <a:solidFill>
            <a:schemeClr val="tx1"/>
          </a:solidFill>
          <a:latin typeface="+mn-lt"/>
          <a:ea typeface="+mn-ea"/>
          <a:cs typeface="+mn-cs"/>
        </a:defRPr>
      </a:lvl3pPr>
      <a:lvl4pPr marL="4859853" algn="l" defTabSz="3239902" rtl="0" eaLnBrk="1" latinLnBrk="0" hangingPunct="1">
        <a:defRPr sz="6378" kern="1200">
          <a:solidFill>
            <a:schemeClr val="tx1"/>
          </a:solidFill>
          <a:latin typeface="+mn-lt"/>
          <a:ea typeface="+mn-ea"/>
          <a:cs typeface="+mn-cs"/>
        </a:defRPr>
      </a:lvl4pPr>
      <a:lvl5pPr marL="6479804" algn="l" defTabSz="3239902" rtl="0" eaLnBrk="1" latinLnBrk="0" hangingPunct="1">
        <a:defRPr sz="6378" kern="1200">
          <a:solidFill>
            <a:schemeClr val="tx1"/>
          </a:solidFill>
          <a:latin typeface="+mn-lt"/>
          <a:ea typeface="+mn-ea"/>
          <a:cs typeface="+mn-cs"/>
        </a:defRPr>
      </a:lvl5pPr>
      <a:lvl6pPr marL="8099755" algn="l" defTabSz="3239902" rtl="0" eaLnBrk="1" latinLnBrk="0" hangingPunct="1">
        <a:defRPr sz="6378" kern="1200">
          <a:solidFill>
            <a:schemeClr val="tx1"/>
          </a:solidFill>
          <a:latin typeface="+mn-lt"/>
          <a:ea typeface="+mn-ea"/>
          <a:cs typeface="+mn-cs"/>
        </a:defRPr>
      </a:lvl6pPr>
      <a:lvl7pPr marL="9719706" algn="l" defTabSz="3239902" rtl="0" eaLnBrk="1" latinLnBrk="0" hangingPunct="1">
        <a:defRPr sz="6378" kern="1200">
          <a:solidFill>
            <a:schemeClr val="tx1"/>
          </a:solidFill>
          <a:latin typeface="+mn-lt"/>
          <a:ea typeface="+mn-ea"/>
          <a:cs typeface="+mn-cs"/>
        </a:defRPr>
      </a:lvl7pPr>
      <a:lvl8pPr marL="11339657" algn="l" defTabSz="3239902" rtl="0" eaLnBrk="1" latinLnBrk="0" hangingPunct="1">
        <a:defRPr sz="6378" kern="1200">
          <a:solidFill>
            <a:schemeClr val="tx1"/>
          </a:solidFill>
          <a:latin typeface="+mn-lt"/>
          <a:ea typeface="+mn-ea"/>
          <a:cs typeface="+mn-cs"/>
        </a:defRPr>
      </a:lvl8pPr>
      <a:lvl9pPr marL="12959608" algn="l" defTabSz="3239902" rtl="0" eaLnBrk="1" latinLnBrk="0" hangingPunct="1">
        <a:defRPr sz="637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211014" y="211014"/>
            <a:ext cx="32188274" cy="4936575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90000"/>
              </a:lnSpc>
            </a:pP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Courier New" panose="02070309020205020404" pitchFamily="49" charset="0"/>
              </a:rPr>
              <a:t>                      1         </a:t>
            </a:r>
            <a:r>
              <a:rPr lang="en-US" altLang="zh-CN" sz="3400" b="1" i="1" dirty="0">
                <a:solidFill>
                  <a:srgbClr val="3333FF"/>
                </a:solidFill>
                <a:latin typeface="Courier New" panose="02070309020205020404" pitchFamily="49" charset="0"/>
                <a:ea typeface="SimSun" panose="02010600030101010101" pitchFamily="2" charset="-122"/>
                <a:cs typeface="Courier New" panose="02070309020205020404" pitchFamily="49" charset="0"/>
              </a:rPr>
              <a:t>ITS5</a:t>
            </a:r>
            <a:r>
              <a:rPr lang="en-US" sz="3400" b="1" dirty="0">
                <a:solidFill>
                  <a:srgbClr val="FF0000"/>
                </a:solidFill>
                <a:latin typeface="Courier New" panose="02070309020205020404" pitchFamily="49" charset="0"/>
                <a:ea typeface="SimSun" panose="02010600030101010101" pitchFamily="2" charset="-122"/>
                <a:cs typeface="Courier New" panose="02070309020205020404" pitchFamily="49" charset="0"/>
              </a:rPr>
              <a:t>               </a:t>
            </a:r>
            <a:r>
              <a:rPr lang="en-US" sz="3400" b="1" i="1" dirty="0">
                <a:solidFill>
                  <a:srgbClr val="FF0000"/>
                </a:solidFill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HsATp1</a:t>
            </a:r>
            <a:r>
              <a:rPr lang="en-US" sz="3400" b="1" dirty="0">
                <a:solidFill>
                  <a:srgbClr val="FF0000"/>
                </a:solidFill>
                <a:latin typeface="Courier New" panose="02070309020205020404" pitchFamily="49" charset="0"/>
                <a:ea typeface="SimSun" panose="02010600030101010101" pitchFamily="2" charset="-122"/>
                <a:cs typeface="Courier New" panose="02070309020205020404" pitchFamily="49" charset="0"/>
              </a:rPr>
              <a:t>                             </a:t>
            </a:r>
            <a:r>
              <a:rPr lang="en-US" sz="3400" b="1" i="1" dirty="0">
                <a:solidFill>
                  <a:srgbClr val="3333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Hsprp1</a:t>
            </a: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Courier New" panose="02070309020205020404" pitchFamily="49" charset="0"/>
              </a:rPr>
              <a:t>                           100</a:t>
            </a:r>
            <a:endParaRPr lang="en-US" sz="3400" dirty="0">
              <a:latin typeface="Courier New" panose="02070309020205020404" pitchFamily="49" charset="0"/>
              <a:ea typeface="SimSun" panose="02010600030101010101" pitchFamily="2" charset="-122"/>
              <a:cs typeface="Courier New" panose="02070309020205020404" pitchFamily="49" charset="0"/>
            </a:endParaRPr>
          </a:p>
          <a:p>
            <a:pPr>
              <a:lnSpc>
                <a:spcPct val="90000"/>
              </a:lnSpc>
            </a:pP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GT1  AB067721   1     TAGA</a:t>
            </a:r>
            <a:r>
              <a:rPr lang="en-US" sz="3400" b="1" dirty="0">
                <a:solidFill>
                  <a:srgbClr val="3333FF"/>
                </a:solidFill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GGAAGTAAAAGTCGTAACAAG</a:t>
            </a: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GTCTCCGTTGGTGAACCAGCGGAGGGATC</a:t>
            </a:r>
            <a:r>
              <a:rPr lang="en-US" sz="3400" b="1" dirty="0">
                <a:solidFill>
                  <a:srgbClr val="3333FF"/>
                </a:solidFill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ATTATCGAGTCACCACTCCCAAACCCCC</a:t>
            </a: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TGCGAACACCACAGCAGT</a:t>
            </a:r>
            <a:endParaRPr lang="en-US" sz="34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  <a:tabLst>
                <a:tab pos="603882" algn="l"/>
                <a:tab pos="1207765" algn="l"/>
                <a:tab pos="1811647" algn="l"/>
                <a:tab pos="2415530" algn="l"/>
                <a:tab pos="3019412" algn="l"/>
                <a:tab pos="3623295" algn="l"/>
                <a:tab pos="4227168" algn="l"/>
                <a:tab pos="4831060" algn="l"/>
                <a:tab pos="5434933" algn="l"/>
                <a:tab pos="6038816" algn="l"/>
                <a:tab pos="6642698" algn="l"/>
                <a:tab pos="7246581" algn="l"/>
                <a:tab pos="7850463" algn="l"/>
                <a:tab pos="8454346" algn="l"/>
                <a:tab pos="9058228" algn="l"/>
                <a:tab pos="9662111" algn="l"/>
              </a:tabLst>
            </a:pPr>
            <a:r>
              <a:rPr lang="en-US" sz="3400" b="1" dirty="0"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JAAVMX010000017 9695  </a:t>
            </a: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----------------------------------------------------------------------------------------------------</a:t>
            </a:r>
            <a:endParaRPr lang="en-US" sz="34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  <a:tabLst>
                <a:tab pos="603882" algn="l"/>
                <a:tab pos="1207765" algn="l"/>
                <a:tab pos="1811647" algn="l"/>
                <a:tab pos="2415530" algn="l"/>
                <a:tab pos="3019412" algn="l"/>
                <a:tab pos="3623295" algn="l"/>
                <a:tab pos="4227168" algn="l"/>
                <a:tab pos="4831060" algn="l"/>
                <a:tab pos="5434933" algn="l"/>
                <a:tab pos="6038816" algn="l"/>
                <a:tab pos="6642698" algn="l"/>
                <a:tab pos="7246581" algn="l"/>
                <a:tab pos="7850463" algn="l"/>
                <a:tab pos="8454346" algn="l"/>
                <a:tab pos="9058228" algn="l"/>
                <a:tab pos="9662111" algn="l"/>
              </a:tabLst>
            </a:pPr>
            <a:r>
              <a:rPr lang="en-US" sz="3400" b="1" dirty="0"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LKHE01000582    2074  </a:t>
            </a: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----------------------------------------------------------------------------------------------------</a:t>
            </a:r>
            <a:endParaRPr lang="en-US" sz="34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  <a:tabLst>
                <a:tab pos="603882" algn="l"/>
                <a:tab pos="1207765" algn="l"/>
                <a:tab pos="1811647" algn="l"/>
                <a:tab pos="2415530" algn="l"/>
                <a:tab pos="3019412" algn="l"/>
                <a:tab pos="3623295" algn="l"/>
                <a:tab pos="4227168" algn="l"/>
                <a:tab pos="4831060" algn="l"/>
                <a:tab pos="5434933" algn="l"/>
                <a:tab pos="6038816" algn="l"/>
                <a:tab pos="6642698" algn="l"/>
                <a:tab pos="7246581" algn="l"/>
                <a:tab pos="7850463" algn="l"/>
                <a:tab pos="8454346" algn="l"/>
                <a:tab pos="9058228" algn="l"/>
                <a:tab pos="9662111" algn="l"/>
              </a:tabLst>
            </a:pPr>
            <a:r>
              <a:rPr lang="en-US" sz="3400" b="1" dirty="0"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OV01021709    838   </a:t>
            </a: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--------------------------C-------------------------------------------------------------------------</a:t>
            </a:r>
            <a:endParaRPr lang="en-US" sz="34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  <a:tabLst>
                <a:tab pos="603882" algn="l"/>
                <a:tab pos="1207765" algn="l"/>
                <a:tab pos="1811647" algn="l"/>
                <a:tab pos="2415530" algn="l"/>
                <a:tab pos="3019412" algn="l"/>
                <a:tab pos="3623295" algn="l"/>
                <a:tab pos="4227168" algn="l"/>
                <a:tab pos="4831060" algn="l"/>
                <a:tab pos="5434933" algn="l"/>
                <a:tab pos="6038816" algn="l"/>
                <a:tab pos="6642698" algn="l"/>
                <a:tab pos="7246581" algn="l"/>
                <a:tab pos="7850463" algn="l"/>
                <a:tab pos="8454346" algn="l"/>
                <a:tab pos="9058228" algn="l"/>
                <a:tab pos="9662111" algn="l"/>
              </a:tabLst>
            </a:pPr>
            <a:r>
              <a:rPr lang="en-US" sz="3400" b="1" dirty="0"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LWBQ01000008  991739  </a:t>
            </a: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----------------------------------------------------------------------------------------------------</a:t>
            </a:r>
            <a:endParaRPr lang="en-US" sz="34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</a:pP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GT2  MG770309 </a:t>
            </a:r>
            <a:endParaRPr lang="en-US" sz="34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</a:pP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GT3  HM595984   1                               --------------------------------CT----TG-----------A----C-T---------------</a:t>
            </a:r>
            <a:endParaRPr lang="en-US" sz="34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</a:pP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GT4  AB067744   1         ------------------</a:t>
            </a:r>
            <a:r>
              <a:rPr lang="en-US" sz="3400" b="1" dirty="0">
                <a:solidFill>
                  <a:srgbClr val="FF0000"/>
                </a:solidFill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AAGGTCTCCGTTAGTAAACT</a:t>
            </a: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-----------T----------T--------T--------------T--T--------</a:t>
            </a:r>
            <a:endParaRPr lang="en-US" sz="34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</a:pP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GT5  AB067740   1     --A------------------T------------A--A---T-----------T----------T--T----TT---------ATA--T--T-T------</a:t>
            </a:r>
            <a:endParaRPr lang="en-US" sz="34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</a:pP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GT6  EU555436   1                                                                                           --T--T-T------</a:t>
            </a:r>
            <a:endParaRPr lang="en-US" sz="34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</a:pP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GT15 KT232017   1                           ------------A--A---T-----------T----------T--------T--------------T--T-T------</a:t>
            </a:r>
            <a:endParaRPr lang="en-US" sz="34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</a:pP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GT16 KT232019   1                           ------------A--A---T-----------T----------T--T-----T--------------T--T-T------</a:t>
            </a:r>
            <a:endParaRPr lang="en-US" sz="34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</a:pP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GT17 KT232010   1                           ------------A--A---T-----------T----------T--T-----T--------------T--T-T------</a:t>
            </a:r>
            <a:endParaRPr lang="en-US" sz="34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</a:pP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 </a:t>
            </a:r>
            <a:endParaRPr lang="en-US" sz="34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</a:pP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                      101                                                                              </a:t>
            </a:r>
            <a:r>
              <a:rPr lang="en-US" sz="3400" b="1" i="1" dirty="0">
                <a:solidFill>
                  <a:srgbClr val="3333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Hsprp2</a:t>
            </a:r>
            <a:r>
              <a:rPr lang="en-US" sz="3400" b="1" dirty="0">
                <a:solidFill>
                  <a:srgbClr val="3333FF"/>
                </a:solidFill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3400" b="1" i="1" dirty="0">
                <a:solidFill>
                  <a:srgbClr val="3333FF"/>
                </a:solidFill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(RC)</a:t>
            </a: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     200</a:t>
            </a:r>
            <a:endParaRPr lang="en-US" sz="34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</a:pP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GT1  AB067721   101   TGCCTCGGCGGGACCGCCCCGGCGCCCCAGGGCCCGGACCAGGGCGCCCGCCGGAGGACCCCCAGACCCTCCTGTCGCAGT</a:t>
            </a:r>
            <a:r>
              <a:rPr lang="en-US" sz="3400" b="1" dirty="0">
                <a:solidFill>
                  <a:srgbClr val="3333FF"/>
                </a:solidFill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GGCATCTCTCAGTCAAGAA</a:t>
            </a:r>
            <a:endParaRPr lang="en-US" sz="3400" dirty="0">
              <a:solidFill>
                <a:srgbClr val="3333FF"/>
              </a:solidFill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  <a:tabLst>
                <a:tab pos="603882" algn="l"/>
                <a:tab pos="1207765" algn="l"/>
                <a:tab pos="1811647" algn="l"/>
                <a:tab pos="2415530" algn="l"/>
                <a:tab pos="3019412" algn="l"/>
                <a:tab pos="3623295" algn="l"/>
                <a:tab pos="4227168" algn="l"/>
                <a:tab pos="4831060" algn="l"/>
                <a:tab pos="5434933" algn="l"/>
                <a:tab pos="6038816" algn="l"/>
                <a:tab pos="6642698" algn="l"/>
                <a:tab pos="7246581" algn="l"/>
                <a:tab pos="7850463" algn="l"/>
                <a:tab pos="8454346" algn="l"/>
                <a:tab pos="9058228" algn="l"/>
                <a:tab pos="9662111" algn="l"/>
              </a:tabLst>
            </a:pPr>
            <a:r>
              <a:rPr lang="en-US" sz="3400" b="1" dirty="0"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JAAVMX010000017 9595  </a:t>
            </a: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----------------------------------------------------------------------------------------------------</a:t>
            </a:r>
            <a:endParaRPr lang="en-US" sz="34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  <a:tabLst>
                <a:tab pos="603882" algn="l"/>
                <a:tab pos="1207765" algn="l"/>
                <a:tab pos="1811647" algn="l"/>
                <a:tab pos="2415530" algn="l"/>
                <a:tab pos="3019412" algn="l"/>
                <a:tab pos="3623295" algn="l"/>
                <a:tab pos="4227168" algn="l"/>
                <a:tab pos="4831060" algn="l"/>
                <a:tab pos="5434933" algn="l"/>
                <a:tab pos="6038816" algn="l"/>
                <a:tab pos="6642698" algn="l"/>
                <a:tab pos="7246581" algn="l"/>
                <a:tab pos="7850463" algn="l"/>
                <a:tab pos="8454346" algn="l"/>
                <a:tab pos="9058228" algn="l"/>
                <a:tab pos="9662111" algn="l"/>
              </a:tabLst>
            </a:pPr>
            <a:r>
              <a:rPr lang="en-US" sz="3400" b="1" dirty="0"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LKHE01000582    2174  </a:t>
            </a: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----------------------------------------------------------------------------------------------------</a:t>
            </a:r>
            <a:endParaRPr lang="en-US" sz="34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  <a:tabLst>
                <a:tab pos="603882" algn="l"/>
                <a:tab pos="1207765" algn="l"/>
                <a:tab pos="1811647" algn="l"/>
                <a:tab pos="2415530" algn="l"/>
                <a:tab pos="3019412" algn="l"/>
                <a:tab pos="3623295" algn="l"/>
                <a:tab pos="4227168" algn="l"/>
                <a:tab pos="4831060" algn="l"/>
                <a:tab pos="5434933" algn="l"/>
                <a:tab pos="6038816" algn="l"/>
                <a:tab pos="6642698" algn="l"/>
                <a:tab pos="7246581" algn="l"/>
                <a:tab pos="7850463" algn="l"/>
                <a:tab pos="8454346" algn="l"/>
                <a:tab pos="9058228" algn="l"/>
                <a:tab pos="9662111" algn="l"/>
              </a:tabLst>
            </a:pPr>
            <a:r>
              <a:rPr lang="en-US" sz="3400" b="1" dirty="0"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OV01021709    938   </a:t>
            </a: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----------------------------------------------------------------------------------------------------</a:t>
            </a:r>
            <a:endParaRPr lang="en-US" sz="34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  <a:tabLst>
                <a:tab pos="603882" algn="l"/>
                <a:tab pos="1207765" algn="l"/>
                <a:tab pos="1811647" algn="l"/>
                <a:tab pos="2415530" algn="l"/>
                <a:tab pos="3019412" algn="l"/>
                <a:tab pos="3623295" algn="l"/>
                <a:tab pos="4227168" algn="l"/>
                <a:tab pos="4831060" algn="l"/>
                <a:tab pos="5434933" algn="l"/>
                <a:tab pos="6038816" algn="l"/>
                <a:tab pos="6642698" algn="l"/>
                <a:tab pos="7246581" algn="l"/>
                <a:tab pos="7850463" algn="l"/>
                <a:tab pos="8454346" algn="l"/>
                <a:tab pos="9058228" algn="l"/>
                <a:tab pos="9662111" algn="l"/>
              </a:tabLst>
            </a:pPr>
            <a:r>
              <a:rPr lang="en-US" sz="3400" b="1" dirty="0"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LWBQ01000008  991839  </a:t>
            </a: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----------------------------------------------------------------------------------------------------</a:t>
            </a:r>
            <a:endParaRPr lang="en-US" sz="34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</a:pP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GT2  MG770309   284                                                                ----C------C-A-----------T-------------</a:t>
            </a:r>
            <a:endParaRPr lang="en-US" sz="34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</a:pP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GT3  HM595984   75    ---------------------------------------T--------------------------------------------G---------------</a:t>
            </a:r>
            <a:endParaRPr lang="en-US" sz="34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</a:pP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GT4  AB067744   97    ---------------------------T-----------T---------------------TT----------A---T---A--------T---T-----</a:t>
            </a:r>
            <a:endParaRPr lang="en-US" sz="34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</a:pP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GT5  AB067740   101   -----TA------------TA------T-A---------T-AA------------------TT----------A-TAT---A-T------T---T-----</a:t>
            </a:r>
            <a:endParaRPr lang="en-US" sz="34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</a:pP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GT6  EU555436   15    -----TA------------TA------T-A---------T---------------------TT----------A---T---A-T------T---T-----</a:t>
            </a:r>
            <a:endParaRPr lang="en-US" sz="34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</a:pP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GT15 KT232017   78    ---------------------------T-----------T---------------------TT----------A-------A--------T---T-----</a:t>
            </a:r>
            <a:endParaRPr lang="en-US" sz="34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</a:pP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GT16 KT232019   78    -----TA------------TA------T-A-A-------T-AA------------------TT----------A-------A-T------T---T-----</a:t>
            </a:r>
            <a:endParaRPr lang="en-US" sz="34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</a:pP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GT17 KT232010   78    -----TA------------TA------T-A---------T-AA------------------TT----------A-TAT---A-T------T---T-----</a:t>
            </a:r>
            <a:endParaRPr lang="en-US" sz="34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</a:pP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 </a:t>
            </a:r>
            <a:endParaRPr lang="en-US" sz="34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</a:pP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                      201                                                                                              300</a:t>
            </a:r>
            <a:endParaRPr lang="en-US" sz="34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</a:pP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GT1  AB067721   201   </a:t>
            </a:r>
            <a:r>
              <a:rPr lang="en-US" sz="3400" b="1" dirty="0">
                <a:solidFill>
                  <a:srgbClr val="3333FF"/>
                </a:solidFill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GCAAGCAAAT</a:t>
            </a: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GAATCAAAACTTTCAACAACGGATCTCTTGGTTCTGGCATCGATGAAGAACGCAGCGAAATGCGATAAGTAATGTGAATTGCA</a:t>
            </a:r>
            <a:r>
              <a:rPr lang="en-US" sz="3400" b="1" u="sng" dirty="0">
                <a:solidFill>
                  <a:srgbClr val="009900"/>
                </a:solidFill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GAATTC</a:t>
            </a: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A</a:t>
            </a:r>
          </a:p>
          <a:p>
            <a:pPr>
              <a:lnSpc>
                <a:spcPct val="90000"/>
              </a:lnSpc>
              <a:tabLst>
                <a:tab pos="603882" algn="l"/>
                <a:tab pos="1207765" algn="l"/>
                <a:tab pos="1811647" algn="l"/>
                <a:tab pos="2415530" algn="l"/>
                <a:tab pos="3019412" algn="l"/>
                <a:tab pos="3623295" algn="l"/>
                <a:tab pos="4227168" algn="l"/>
                <a:tab pos="4831060" algn="l"/>
                <a:tab pos="5434933" algn="l"/>
                <a:tab pos="6038816" algn="l"/>
                <a:tab pos="6642698" algn="l"/>
                <a:tab pos="7246581" algn="l"/>
                <a:tab pos="7850463" algn="l"/>
                <a:tab pos="8454346" algn="l"/>
                <a:tab pos="9058228" algn="l"/>
                <a:tab pos="9662111" algn="l"/>
              </a:tabLst>
            </a:pP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JAAVMX010000017 9495  ----------------------------------------------------------------------------------------------------</a:t>
            </a:r>
            <a:endParaRPr lang="en-US" sz="34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  <a:tabLst>
                <a:tab pos="603882" algn="l"/>
                <a:tab pos="1207765" algn="l"/>
                <a:tab pos="1811647" algn="l"/>
                <a:tab pos="2415530" algn="l"/>
                <a:tab pos="3019412" algn="l"/>
                <a:tab pos="3623295" algn="l"/>
                <a:tab pos="4227168" algn="l"/>
                <a:tab pos="4831060" algn="l"/>
                <a:tab pos="5434933" algn="l"/>
                <a:tab pos="6038816" algn="l"/>
                <a:tab pos="6642698" algn="l"/>
                <a:tab pos="7246581" algn="l"/>
                <a:tab pos="7850463" algn="l"/>
                <a:tab pos="8454346" algn="l"/>
                <a:tab pos="9058228" algn="l"/>
                <a:tab pos="9662111" algn="l"/>
              </a:tabLst>
            </a:pPr>
            <a:r>
              <a:rPr lang="en-US" sz="3400" b="1" dirty="0"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LKHE01000582    2274  </a:t>
            </a: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----------------------------------------------------------------------------------------------------</a:t>
            </a:r>
            <a:endParaRPr lang="en-US" sz="34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  <a:tabLst>
                <a:tab pos="603882" algn="l"/>
                <a:tab pos="1207765" algn="l"/>
                <a:tab pos="1811647" algn="l"/>
                <a:tab pos="2415530" algn="l"/>
                <a:tab pos="3019412" algn="l"/>
                <a:tab pos="3623295" algn="l"/>
                <a:tab pos="4227168" algn="l"/>
                <a:tab pos="4831060" algn="l"/>
                <a:tab pos="5434933" algn="l"/>
                <a:tab pos="6038816" algn="l"/>
                <a:tab pos="6642698" algn="l"/>
                <a:tab pos="7246581" algn="l"/>
                <a:tab pos="7850463" algn="l"/>
                <a:tab pos="8454346" algn="l"/>
                <a:tab pos="9058228" algn="l"/>
                <a:tab pos="9662111" algn="l"/>
              </a:tabLst>
            </a:pPr>
            <a:r>
              <a:rPr lang="en-US" sz="3400" b="1" dirty="0"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OV01021709    1038  </a:t>
            </a: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----------------------------------------------------------------------------------------------------</a:t>
            </a:r>
            <a:endParaRPr lang="en-US" sz="34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  <a:tabLst>
                <a:tab pos="603882" algn="l"/>
                <a:tab pos="1207765" algn="l"/>
                <a:tab pos="1811647" algn="l"/>
                <a:tab pos="2415530" algn="l"/>
                <a:tab pos="3019412" algn="l"/>
                <a:tab pos="3623295" algn="l"/>
                <a:tab pos="4227168" algn="l"/>
                <a:tab pos="4831060" algn="l"/>
                <a:tab pos="5434933" algn="l"/>
                <a:tab pos="6038816" algn="l"/>
                <a:tab pos="6642698" algn="l"/>
                <a:tab pos="7246581" algn="l"/>
                <a:tab pos="7850463" algn="l"/>
                <a:tab pos="8454346" algn="l"/>
                <a:tab pos="9058228" algn="l"/>
                <a:tab pos="9662111" algn="l"/>
              </a:tabLst>
            </a:pPr>
            <a:r>
              <a:rPr lang="en-US" sz="3400" b="1" dirty="0"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LWBQ01000008  991939  </a:t>
            </a: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----------------------------------------------------------------------------------------------------</a:t>
            </a:r>
            <a:endParaRPr lang="en-US" sz="34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</a:pP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GT2  MG770309   245   -----------------------------------------------------------GA--------- C----------------------------</a:t>
            </a:r>
            <a:endParaRPr lang="en-US" sz="34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</a:pP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GT3  HM595984   175   ----------------------------------------------------------------------------------------------------</a:t>
            </a:r>
            <a:endParaRPr lang="en-US" sz="34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</a:pP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GT4  AB067744   197   ----------A---T--------T--T------------A---T-A----TA--A----------------A-------------A-----T------T-</a:t>
            </a:r>
            <a:endParaRPr lang="en-US" sz="34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</a:pP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GT5  AB067740   201   ----------A---T--------T---------------A-----A----TA--A--A---------------A---------A-A----A-------T-</a:t>
            </a:r>
            <a:endParaRPr lang="en-US" sz="34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</a:pP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GT6  EU555436   115   ----------A---T--------T---------------A-----A--------A-------T--TA----------------A-A----A-------T-</a:t>
            </a:r>
            <a:endParaRPr lang="en-US" sz="34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</a:pP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GT15 KT232017   178   --------------T--------T--T------------A---T-A----TA--A----------------A-------------A-----T------T-</a:t>
            </a:r>
            <a:endParaRPr lang="en-US" sz="34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</a:pP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GT16 KT232019   178   ----------A---T--------T---------------A-----A--------A--A---------------A---------A-A----A-------T-</a:t>
            </a:r>
            <a:endParaRPr lang="en-US" sz="34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</a:pP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GT17 KT232010   178   ----------A---T--------T---------------A-----A--------A--A---------------A---------A-A----A-------T-</a:t>
            </a:r>
            <a:endParaRPr lang="en-US" sz="34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</a:pP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 </a:t>
            </a:r>
            <a:endParaRPr lang="en-US" sz="34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</a:pP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                      301                                                                   </a:t>
            </a:r>
            <a:r>
              <a:rPr lang="en-US" sz="3400" b="1" i="1" dirty="0">
                <a:solidFill>
                  <a:srgbClr val="FF0000"/>
                </a:solidFill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HsATp2/HsATp3 (RC)</a:t>
            </a:r>
            <a:r>
              <a:rPr lang="en-US" sz="3400" b="1" dirty="0">
                <a:solidFill>
                  <a:srgbClr val="FF0000"/>
                </a:solidFill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         </a:t>
            </a: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400</a:t>
            </a:r>
            <a:endParaRPr lang="en-US" sz="34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</a:pP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GT1  AB067721   301   GTGAACCATCGAATCTTTGAACGCACATTGCGCCCGCCAGCACTCTGGCGGGCATGCCTGTCCGAGCGTCATCTCAACCCTCGAGCCCCCCGCCTCGCGG</a:t>
            </a:r>
            <a:endParaRPr lang="en-US" sz="34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  <a:tabLst>
                <a:tab pos="603882" algn="l"/>
                <a:tab pos="1207765" algn="l"/>
                <a:tab pos="1811647" algn="l"/>
                <a:tab pos="2415530" algn="l"/>
                <a:tab pos="3019412" algn="l"/>
                <a:tab pos="3623295" algn="l"/>
                <a:tab pos="4227168" algn="l"/>
                <a:tab pos="4831060" algn="l"/>
                <a:tab pos="5434933" algn="l"/>
                <a:tab pos="6038816" algn="l"/>
                <a:tab pos="6642698" algn="l"/>
                <a:tab pos="7246581" algn="l"/>
                <a:tab pos="7850463" algn="l"/>
                <a:tab pos="8454346" algn="l"/>
                <a:tab pos="9058228" algn="l"/>
                <a:tab pos="9662111" algn="l"/>
              </a:tabLst>
            </a:pPr>
            <a:r>
              <a:rPr lang="en-US" sz="3400" b="1" dirty="0"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JAAVMX010000017 9395  </a:t>
            </a: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----------------------------------------------------------------------------------------------------</a:t>
            </a:r>
            <a:endParaRPr lang="en-US" sz="34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  <a:tabLst>
                <a:tab pos="603882" algn="l"/>
                <a:tab pos="1207765" algn="l"/>
                <a:tab pos="1811647" algn="l"/>
                <a:tab pos="2415530" algn="l"/>
                <a:tab pos="3019412" algn="l"/>
                <a:tab pos="3623295" algn="l"/>
                <a:tab pos="4227168" algn="l"/>
                <a:tab pos="4831060" algn="l"/>
                <a:tab pos="5434933" algn="l"/>
                <a:tab pos="6038816" algn="l"/>
                <a:tab pos="6642698" algn="l"/>
                <a:tab pos="7246581" algn="l"/>
                <a:tab pos="7850463" algn="l"/>
                <a:tab pos="8454346" algn="l"/>
                <a:tab pos="9058228" algn="l"/>
                <a:tab pos="9662111" algn="l"/>
              </a:tabLst>
            </a:pPr>
            <a:r>
              <a:rPr lang="en-US" sz="3400" b="1" dirty="0"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LKHE01000582    2374  </a:t>
            </a: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----------------------------------------------------------------------------------------------------</a:t>
            </a:r>
            <a:endParaRPr lang="en-US" sz="34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  <a:tabLst>
                <a:tab pos="603882" algn="l"/>
                <a:tab pos="1207765" algn="l"/>
                <a:tab pos="1811647" algn="l"/>
                <a:tab pos="2415530" algn="l"/>
                <a:tab pos="3019412" algn="l"/>
                <a:tab pos="3623295" algn="l"/>
                <a:tab pos="4227168" algn="l"/>
                <a:tab pos="4831060" algn="l"/>
                <a:tab pos="5434933" algn="l"/>
                <a:tab pos="6038816" algn="l"/>
                <a:tab pos="6642698" algn="l"/>
                <a:tab pos="7246581" algn="l"/>
                <a:tab pos="7850463" algn="l"/>
                <a:tab pos="8454346" algn="l"/>
                <a:tab pos="9058228" algn="l"/>
                <a:tab pos="9662111" algn="l"/>
              </a:tabLst>
            </a:pPr>
            <a:r>
              <a:rPr lang="en-US" sz="3400" b="1" dirty="0"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OV01021709    1138  </a:t>
            </a: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----------------------------------------------------------------------------------------------------</a:t>
            </a:r>
            <a:endParaRPr lang="en-US" sz="34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  <a:tabLst>
                <a:tab pos="603882" algn="l"/>
                <a:tab pos="1207765" algn="l"/>
                <a:tab pos="1811647" algn="l"/>
                <a:tab pos="2415530" algn="l"/>
                <a:tab pos="3019412" algn="l"/>
                <a:tab pos="3623295" algn="l"/>
                <a:tab pos="4227168" algn="l"/>
                <a:tab pos="4831060" algn="l"/>
                <a:tab pos="5434933" algn="l"/>
                <a:tab pos="6038816" algn="l"/>
                <a:tab pos="6642698" algn="l"/>
                <a:tab pos="7246581" algn="l"/>
                <a:tab pos="7850463" algn="l"/>
                <a:tab pos="8454346" algn="l"/>
                <a:tab pos="9058228" algn="l"/>
                <a:tab pos="9662111" algn="l"/>
              </a:tabLst>
            </a:pPr>
            <a:r>
              <a:rPr lang="en-US" sz="3400" b="1" dirty="0"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LWBQ01000008  992039  </a:t>
            </a: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----------------------------------------------------------------------------------------------------</a:t>
            </a:r>
            <a:endParaRPr lang="en-US" sz="34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</a:pP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GT2  MG770309   146   ----------------------------------------------------------------------------------------------------</a:t>
            </a:r>
            <a:endParaRPr lang="en-US" sz="34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</a:pP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GT3  HM595984   275   ----------------------------------------------A-----------------------------------------------------</a:t>
            </a:r>
            <a:endParaRPr lang="en-US" sz="34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</a:pP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GT4  AB067744   297   --A---T-----------A----T-T-C-A-------T--------A----------------------</a:t>
            </a:r>
            <a:r>
              <a:rPr lang="en-US" sz="3400" b="1" dirty="0">
                <a:solidFill>
                  <a:srgbClr val="FF0000"/>
                </a:solidFill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TACCTTAACCCTTAAGCCCC</a:t>
            </a: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-----------</a:t>
            </a:r>
            <a:endParaRPr lang="en-US" sz="34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</a:pP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GT5  AB067740   301   --A---T-----------A------T---A-------T--------A------------A---------</a:t>
            </a:r>
            <a:r>
              <a:rPr lang="en-US" sz="3400" b="1" dirty="0">
                <a:solidFill>
                  <a:srgbClr val="FF0000"/>
                </a:solidFill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TATCTTAACCCTCGAGCCCC</a:t>
            </a: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-----------</a:t>
            </a:r>
            <a:endParaRPr lang="en-US" sz="34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</a:pP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GT6  EU555436   215   --A---------------A----T-T---A-------T--------A----------------------T----T--------------------TA---</a:t>
            </a:r>
            <a:endParaRPr lang="en-US" sz="34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</a:pP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GT15 KT232017   278   --A---T-----------A----T-T---A-------T--------A----------------------T----T-------------------------</a:t>
            </a:r>
            <a:endParaRPr lang="en-US" sz="34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</a:pP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GT16 KT232019   278   --A---T-----------A----T-T---A-------T--------A----------------------T-C--T------TA-----------------</a:t>
            </a:r>
            <a:endParaRPr lang="en-US" sz="34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</a:pP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GT17 KT232010   278   --A---T-----------A------T-----------T--------A------------A---------T----T-------------------------</a:t>
            </a:r>
            <a:endParaRPr lang="en-US" sz="34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</a:pPr>
            <a:endParaRPr lang="en-US" sz="3400" b="1" dirty="0">
              <a:latin typeface="Courier New" panose="02070309020205020404" pitchFamily="49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</a:pP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                      401                                                                                 </a:t>
            </a:r>
            <a:r>
              <a:rPr lang="en-US" sz="3400" b="1" i="1" dirty="0">
                <a:solidFill>
                  <a:srgbClr val="3333FF"/>
                </a:solidFill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Hsprp3 (RC)</a:t>
            </a:r>
            <a:r>
              <a:rPr lang="en-US" sz="3400" b="1" dirty="0">
                <a:solidFill>
                  <a:srgbClr val="3333FF"/>
                </a:solidFill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  </a:t>
            </a: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500</a:t>
            </a:r>
            <a:endParaRPr lang="en-US" sz="34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</a:pP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GT1  AB067721   401   CGGCGGGGCCCGGCCTTGGGGGTCACGGCCCCGCGCCGCCCCCTAAACGCAGTGGCGACCCCGCCGCGGCTCCCCTGCGC</a:t>
            </a:r>
            <a:r>
              <a:rPr lang="en-US" sz="3400" b="1" dirty="0">
                <a:solidFill>
                  <a:srgbClr val="3333FF"/>
                </a:solidFill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AGTAGCTCGCTGAG AACCT</a:t>
            </a:r>
            <a:endParaRPr lang="en-US" sz="3400" dirty="0">
              <a:solidFill>
                <a:srgbClr val="3333FF"/>
              </a:solidFill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  <a:tabLst>
                <a:tab pos="603882" algn="l"/>
                <a:tab pos="1207765" algn="l"/>
                <a:tab pos="1811647" algn="l"/>
                <a:tab pos="2415530" algn="l"/>
                <a:tab pos="3019412" algn="l"/>
                <a:tab pos="3623295" algn="l"/>
                <a:tab pos="4227168" algn="l"/>
                <a:tab pos="4831060" algn="l"/>
                <a:tab pos="5434933" algn="l"/>
                <a:tab pos="6038816" algn="l"/>
                <a:tab pos="6642698" algn="l"/>
                <a:tab pos="7246581" algn="l"/>
                <a:tab pos="7850463" algn="l"/>
                <a:tab pos="8454346" algn="l"/>
                <a:tab pos="9058228" algn="l"/>
                <a:tab pos="9662111" algn="l"/>
              </a:tabLst>
            </a:pPr>
            <a:r>
              <a:rPr lang="en-US" sz="3400" b="1" dirty="0"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JAAVMX010000017 9295  </a:t>
            </a: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---------------------------------------------------------------------------------------------- -----</a:t>
            </a:r>
            <a:endParaRPr lang="en-US" sz="34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  <a:tabLst>
                <a:tab pos="603882" algn="l"/>
                <a:tab pos="1207765" algn="l"/>
                <a:tab pos="1811647" algn="l"/>
                <a:tab pos="2415530" algn="l"/>
                <a:tab pos="3019412" algn="l"/>
                <a:tab pos="3623295" algn="l"/>
                <a:tab pos="4227168" algn="l"/>
                <a:tab pos="4831060" algn="l"/>
                <a:tab pos="5434933" algn="l"/>
                <a:tab pos="6038816" algn="l"/>
                <a:tab pos="6642698" algn="l"/>
                <a:tab pos="7246581" algn="l"/>
                <a:tab pos="7850463" algn="l"/>
                <a:tab pos="8454346" algn="l"/>
                <a:tab pos="9058228" algn="l"/>
                <a:tab pos="9662111" algn="l"/>
              </a:tabLst>
            </a:pPr>
            <a:r>
              <a:rPr lang="en-US" sz="3400" b="1" dirty="0"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LKHE01000582    2474  </a:t>
            </a: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---------------------------------------------------------------------------------------------- -----</a:t>
            </a:r>
            <a:endParaRPr lang="en-US" sz="34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  <a:tabLst>
                <a:tab pos="603882" algn="l"/>
                <a:tab pos="1207765" algn="l"/>
                <a:tab pos="1811647" algn="l"/>
                <a:tab pos="2415530" algn="l"/>
                <a:tab pos="3019412" algn="l"/>
                <a:tab pos="3623295" algn="l"/>
                <a:tab pos="4227168" algn="l"/>
                <a:tab pos="4831060" algn="l"/>
                <a:tab pos="5434933" algn="l"/>
                <a:tab pos="6038816" algn="l"/>
                <a:tab pos="6642698" algn="l"/>
                <a:tab pos="7246581" algn="l"/>
                <a:tab pos="7850463" algn="l"/>
                <a:tab pos="8454346" algn="l"/>
                <a:tab pos="9058228" algn="l"/>
                <a:tab pos="9662111" algn="l"/>
              </a:tabLst>
            </a:pPr>
            <a:r>
              <a:rPr lang="en-US" sz="3400" b="1" dirty="0"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OV01021709    1238  </a:t>
            </a: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---G------------------------------------------------------------------------------------------ -----</a:t>
            </a:r>
            <a:endParaRPr lang="en-US" sz="34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  <a:tabLst>
                <a:tab pos="603882" algn="l"/>
                <a:tab pos="1207765" algn="l"/>
                <a:tab pos="1811647" algn="l"/>
                <a:tab pos="2415530" algn="l"/>
                <a:tab pos="3019412" algn="l"/>
                <a:tab pos="3623295" algn="l"/>
                <a:tab pos="4227168" algn="l"/>
                <a:tab pos="4831060" algn="l"/>
                <a:tab pos="5434933" algn="l"/>
                <a:tab pos="6038816" algn="l"/>
                <a:tab pos="6642698" algn="l"/>
                <a:tab pos="7246581" algn="l"/>
                <a:tab pos="7850463" algn="l"/>
                <a:tab pos="8454346" algn="l"/>
                <a:tab pos="9058228" algn="l"/>
                <a:tab pos="9662111" algn="l"/>
              </a:tabLst>
            </a:pPr>
            <a:r>
              <a:rPr lang="en-US" sz="3400" b="1" dirty="0"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LWBQ01000008  992139  </a:t>
            </a: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---------------------------------------------------------------------------------------------- -----</a:t>
            </a:r>
            <a:endParaRPr lang="en-US" sz="34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</a:pP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GT2  MG770309   46    ----------------------------------------------</a:t>
            </a:r>
            <a:endParaRPr lang="en-US" sz="34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</a:pP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GT3  HM595984   375   --A----------------------------T---------------T------------------------------------------C---G-----</a:t>
            </a:r>
            <a:endParaRPr lang="en-US" sz="34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</a:pP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GT4  AB067744   397   -----------------A--------------A--------------------A-T--------------------</a:t>
            </a:r>
            <a:r>
              <a:rPr lang="en-US" sz="3400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A</a:t>
            </a: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----A-----TA--A-- -----</a:t>
            </a:r>
            <a:endParaRPr lang="en-US" sz="34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</a:pP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GT5  AB067740   401   ---------T-------A-----T------------------T------T---A----------------------A--TG-------A-C--- -----</a:t>
            </a:r>
            <a:endParaRPr lang="en-US" sz="34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</a:pP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GT6  EU555436   315   ---------T-------A-----T------------------T----------A-------T----TA--------</a:t>
            </a:r>
            <a:r>
              <a:rPr lang="en-US" sz="3400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A</a:t>
            </a: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TAT-------TA-C--- -----</a:t>
            </a:r>
            <a:endParaRPr lang="en-US" sz="34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</a:pP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GT15 KT232017   378   ---------T-------A-----T-------------------------T---A----------------------</a:t>
            </a:r>
            <a:r>
              <a:rPr lang="en-US" sz="3400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A</a:t>
            </a: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--T-A------A-C--- -----</a:t>
            </a:r>
            <a:endParaRPr lang="en-US" sz="34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</a:pP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GT16 KT232019   378   -----------------A--------------A--------------------A------------------T---</a:t>
            </a:r>
            <a:r>
              <a:rPr lang="en-US" sz="3400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A</a:t>
            </a: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----A-----TA--A-- -----</a:t>
            </a:r>
            <a:endParaRPr lang="en-US" sz="34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</a:pP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GT17 KT232010   378   ---------T-------A-----T-------------------------T---A----------------------</a:t>
            </a:r>
            <a:r>
              <a:rPr lang="en-US" sz="3400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A</a:t>
            </a: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--T-A------A-C--- -----</a:t>
            </a:r>
            <a:endParaRPr lang="en-US" sz="34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</a:pPr>
            <a:endParaRPr lang="en-US" sz="3400" b="1" dirty="0">
              <a:latin typeface="Courier New" panose="02070309020205020404" pitchFamily="49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</a:pP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Courier New" panose="02070309020205020404" pitchFamily="49" charset="0"/>
              </a:rPr>
              <a:t>                      501                                                                                      </a:t>
            </a:r>
            <a:r>
              <a:rPr lang="en-US" altLang="zh-CN" sz="3400" b="1" i="1" dirty="0">
                <a:solidFill>
                  <a:srgbClr val="3333FF"/>
                </a:solidFill>
                <a:latin typeface="Courier New" panose="02070309020205020404" pitchFamily="49" charset="0"/>
                <a:ea typeface="SimSun" panose="02010600030101010101" pitchFamily="2" charset="-122"/>
                <a:cs typeface="Courier New" panose="02070309020205020404" pitchFamily="49" charset="0"/>
              </a:rPr>
              <a:t>ITS4(RC)</a:t>
            </a: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Courier New" panose="02070309020205020404" pitchFamily="49" charset="0"/>
              </a:rPr>
              <a:t>600</a:t>
            </a:r>
            <a:endParaRPr lang="en-US" sz="3400" dirty="0">
              <a:latin typeface="Courier New" panose="02070309020205020404" pitchFamily="49" charset="0"/>
              <a:ea typeface="SimSun" panose="02010600030101010101" pitchFamily="2" charset="-122"/>
              <a:cs typeface="Courier New" panose="02070309020205020404" pitchFamily="49" charset="0"/>
            </a:endParaRPr>
          </a:p>
          <a:p>
            <a:pPr>
              <a:lnSpc>
                <a:spcPct val="90000"/>
              </a:lnSpc>
            </a:pP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GT1  AB067721   500   </a:t>
            </a:r>
            <a:r>
              <a:rPr lang="en-US" sz="3400" b="1" dirty="0">
                <a:solidFill>
                  <a:srgbClr val="3333FF"/>
                </a:solidFill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CG</a:t>
            </a: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CACCGGGAGCGCGGAGGCGGTCACGCCGTGAAACCACCACACCCTCCAGTTGACCTCGGATCAGGTAGGGATACCCGCTGAACTTAA</a:t>
            </a:r>
            <a:r>
              <a:rPr lang="en-US" sz="3400" b="1" dirty="0">
                <a:solidFill>
                  <a:srgbClr val="3333FF"/>
                </a:solidFill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GCATATCAATA</a:t>
            </a:r>
            <a:endParaRPr lang="en-US" sz="3400" dirty="0">
              <a:solidFill>
                <a:srgbClr val="3333FF"/>
              </a:solidFill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  <a:tabLst>
                <a:tab pos="603882" algn="l"/>
                <a:tab pos="1207765" algn="l"/>
                <a:tab pos="1811647" algn="l"/>
                <a:tab pos="2415530" algn="l"/>
                <a:tab pos="3019412" algn="l"/>
                <a:tab pos="3623295" algn="l"/>
                <a:tab pos="4227168" algn="l"/>
                <a:tab pos="4831060" algn="l"/>
                <a:tab pos="5434933" algn="l"/>
                <a:tab pos="6038816" algn="l"/>
                <a:tab pos="6642698" algn="l"/>
                <a:tab pos="7246581" algn="l"/>
                <a:tab pos="7850463" algn="l"/>
                <a:tab pos="8454346" algn="l"/>
                <a:tab pos="9058228" algn="l"/>
                <a:tab pos="9662111" algn="l"/>
              </a:tabLst>
            </a:pPr>
            <a:r>
              <a:rPr lang="en-US" sz="3400" b="1" dirty="0"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JAAVMX010000017 9194  </a:t>
            </a: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----------------------------------------------------------------------------------------------------</a:t>
            </a:r>
            <a:endParaRPr lang="en-US" sz="34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  <a:tabLst>
                <a:tab pos="603882" algn="l"/>
                <a:tab pos="1207765" algn="l"/>
                <a:tab pos="1811647" algn="l"/>
                <a:tab pos="2415530" algn="l"/>
                <a:tab pos="3019412" algn="l"/>
                <a:tab pos="3623295" algn="l"/>
                <a:tab pos="4227168" algn="l"/>
                <a:tab pos="4831060" algn="l"/>
                <a:tab pos="5434933" algn="l"/>
                <a:tab pos="6038816" algn="l"/>
                <a:tab pos="6642698" algn="l"/>
                <a:tab pos="7246581" algn="l"/>
                <a:tab pos="7850463" algn="l"/>
                <a:tab pos="8454346" algn="l"/>
                <a:tab pos="9058228" algn="l"/>
                <a:tab pos="9662111" algn="l"/>
              </a:tabLst>
            </a:pPr>
            <a:r>
              <a:rPr lang="en-US" sz="3400" b="1" dirty="0"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LKHE01000582    2573  </a:t>
            </a: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----------------------------------------------------------------------------------------------------</a:t>
            </a:r>
            <a:endParaRPr lang="en-US" sz="34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  <a:tabLst>
                <a:tab pos="603882" algn="l"/>
                <a:tab pos="1207765" algn="l"/>
                <a:tab pos="1811647" algn="l"/>
                <a:tab pos="2415530" algn="l"/>
                <a:tab pos="3019412" algn="l"/>
                <a:tab pos="3623295" algn="l"/>
                <a:tab pos="4227168" algn="l"/>
                <a:tab pos="4831060" algn="l"/>
                <a:tab pos="5434933" algn="l"/>
                <a:tab pos="6038816" algn="l"/>
                <a:tab pos="6642698" algn="l"/>
                <a:tab pos="7246581" algn="l"/>
                <a:tab pos="7850463" algn="l"/>
                <a:tab pos="8454346" algn="l"/>
                <a:tab pos="9058228" algn="l"/>
                <a:tab pos="9662111" algn="l"/>
              </a:tabLst>
            </a:pPr>
            <a:r>
              <a:rPr lang="en-US" sz="3400" b="1" dirty="0"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OV01021709    1337  </a:t>
            </a: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----------------------------------------------------------------------------------------------------</a:t>
            </a:r>
            <a:endParaRPr lang="en-US" sz="34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  <a:tabLst>
                <a:tab pos="603882" algn="l"/>
                <a:tab pos="1207765" algn="l"/>
                <a:tab pos="1811647" algn="l"/>
                <a:tab pos="2415530" algn="l"/>
                <a:tab pos="3019412" algn="l"/>
                <a:tab pos="3623295" algn="l"/>
                <a:tab pos="4227168" algn="l"/>
                <a:tab pos="4831060" algn="l"/>
                <a:tab pos="5434933" algn="l"/>
                <a:tab pos="6038816" algn="l"/>
                <a:tab pos="6642698" algn="l"/>
                <a:tab pos="7246581" algn="l"/>
                <a:tab pos="7850463" algn="l"/>
                <a:tab pos="8454346" algn="l"/>
                <a:tab pos="9058228" algn="l"/>
                <a:tab pos="9662111" algn="l"/>
              </a:tabLst>
            </a:pPr>
            <a:r>
              <a:rPr lang="en-US" sz="3400" b="1" dirty="0"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LWBQ01000008  992238  </a:t>
            </a: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---CT--C--------------------------------------------------------------------------------------------</a:t>
            </a:r>
            <a:endParaRPr lang="en-US" sz="34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</a:pP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GT2  MG770309   1</a:t>
            </a:r>
            <a:endParaRPr lang="en-US" sz="34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</a:pP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GT3  HM595984   475   --------A-------G--T----------C------------    ----------</a:t>
            </a:r>
            <a:endParaRPr lang="en-US" sz="34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</a:pP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GT4  AB067744   496   -----TA------------------------A-------T-T------TG---A---------T-----------------A------------------</a:t>
            </a:r>
            <a:endParaRPr lang="en-US" sz="34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</a:pP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GT5  AB067740   500   --------A----------------------A-----T-T--G--T-TT----A---------T-----------------A-------------T----</a:t>
            </a:r>
            <a:endParaRPr lang="en-US" sz="34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</a:pP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GT6  EU555436   414   --------A---A-------TA-A-------T-CG--T--TAG-- </a:t>
            </a:r>
            <a:endParaRPr lang="en-US" sz="34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</a:pP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GT15 KT232017   477   --------A----------------------A-------T--G--T-TT----A---------T-----------------A------------------</a:t>
            </a:r>
            <a:endParaRPr lang="en-US" sz="34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</a:pP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GT16 KT232019   477   -----TA------------------------A-------T-T------T----A---C-----T-A---------------A------------------</a:t>
            </a:r>
            <a:endParaRPr lang="en-US" sz="34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</a:pP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GT17 KT232010   477   --------A----------------------A-------T--G--T-TT----A---------T-----------------A------------------</a:t>
            </a:r>
            <a:endParaRPr lang="en-US" sz="34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</a:pP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 </a:t>
            </a:r>
            <a:endParaRPr lang="en-US" sz="34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</a:pP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                      601                                                                                 686</a:t>
            </a:r>
            <a:endParaRPr lang="en-US" sz="34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</a:pP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GT1  AB067721   600   </a:t>
            </a:r>
            <a:r>
              <a:rPr lang="en-US" sz="3400" b="1" dirty="0">
                <a:solidFill>
                  <a:srgbClr val="3333FF"/>
                </a:solidFill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AGCGGAGGA</a:t>
            </a: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AAAGAAACCAACAGGGATTGCCCCAGTAACGGCGAGTGAAGCGGCAACAGCTCAAATTT</a:t>
            </a:r>
            <a:endParaRPr lang="en-US" sz="34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  <a:tabLst>
                <a:tab pos="603882" algn="l"/>
                <a:tab pos="1207765" algn="l"/>
                <a:tab pos="1811647" algn="l"/>
                <a:tab pos="2415530" algn="l"/>
                <a:tab pos="3019412" algn="l"/>
                <a:tab pos="3623295" algn="l"/>
                <a:tab pos="4227168" algn="l"/>
                <a:tab pos="4831060" algn="l"/>
                <a:tab pos="5434933" algn="l"/>
                <a:tab pos="6038816" algn="l"/>
                <a:tab pos="6642698" algn="l"/>
                <a:tab pos="7246581" algn="l"/>
                <a:tab pos="7850463" algn="l"/>
                <a:tab pos="8454346" algn="l"/>
                <a:tab pos="9058228" algn="l"/>
                <a:tab pos="9662111" algn="l"/>
              </a:tabLst>
            </a:pPr>
            <a:r>
              <a:rPr lang="en-US" sz="3400" b="1" dirty="0"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JAAVMX010000017 9094  </a:t>
            </a: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--------------------------------------------------------------------</a:t>
            </a:r>
            <a:endParaRPr lang="en-US" sz="34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  <a:tabLst>
                <a:tab pos="603882" algn="l"/>
                <a:tab pos="1207765" algn="l"/>
                <a:tab pos="1811647" algn="l"/>
                <a:tab pos="2415530" algn="l"/>
                <a:tab pos="3019412" algn="l"/>
                <a:tab pos="3623295" algn="l"/>
                <a:tab pos="4227168" algn="l"/>
                <a:tab pos="4831060" algn="l"/>
                <a:tab pos="5434933" algn="l"/>
                <a:tab pos="6038816" algn="l"/>
                <a:tab pos="6642698" algn="l"/>
                <a:tab pos="7246581" algn="l"/>
                <a:tab pos="7850463" algn="l"/>
                <a:tab pos="8454346" algn="l"/>
                <a:tab pos="9058228" algn="l"/>
                <a:tab pos="9662111" algn="l"/>
              </a:tabLst>
            </a:pPr>
            <a:r>
              <a:rPr lang="en-US" sz="3400" b="1" dirty="0"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LKHE01000582    2673  </a:t>
            </a: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--------------------------------------------------------------------</a:t>
            </a:r>
            <a:endParaRPr lang="en-US" sz="34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  <a:tabLst>
                <a:tab pos="603882" algn="l"/>
                <a:tab pos="1207765" algn="l"/>
                <a:tab pos="1811647" algn="l"/>
                <a:tab pos="2415530" algn="l"/>
                <a:tab pos="3019412" algn="l"/>
                <a:tab pos="3623295" algn="l"/>
                <a:tab pos="4227168" algn="l"/>
                <a:tab pos="4831060" algn="l"/>
                <a:tab pos="5434933" algn="l"/>
                <a:tab pos="6038816" algn="l"/>
                <a:tab pos="6642698" algn="l"/>
                <a:tab pos="7246581" algn="l"/>
                <a:tab pos="7850463" algn="l"/>
                <a:tab pos="8454346" algn="l"/>
                <a:tab pos="9058228" algn="l"/>
                <a:tab pos="9662111" algn="l"/>
              </a:tabLst>
            </a:pPr>
            <a:r>
              <a:rPr lang="en-US" sz="3400" b="1" dirty="0"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OV01021709    1437  </a:t>
            </a: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--------------------------------------------------------------------</a:t>
            </a:r>
            <a:endParaRPr lang="en-US" sz="34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  <a:tabLst>
                <a:tab pos="603882" algn="l"/>
                <a:tab pos="1207765" algn="l"/>
                <a:tab pos="1811647" algn="l"/>
                <a:tab pos="2415530" algn="l"/>
                <a:tab pos="3019412" algn="l"/>
                <a:tab pos="3623295" algn="l"/>
                <a:tab pos="4227168" algn="l"/>
                <a:tab pos="4831060" algn="l"/>
                <a:tab pos="5434933" algn="l"/>
                <a:tab pos="6038816" algn="l"/>
                <a:tab pos="6642698" algn="l"/>
                <a:tab pos="7246581" algn="l"/>
                <a:tab pos="7850463" algn="l"/>
                <a:tab pos="8454346" algn="l"/>
                <a:tab pos="9058228" algn="l"/>
                <a:tab pos="9662111" algn="l"/>
              </a:tabLst>
            </a:pPr>
            <a:r>
              <a:rPr lang="en-US" sz="3400" b="1" dirty="0">
                <a:latin typeface="Courier New" panose="02070309020205020404" pitchFamily="49" charset="0"/>
                <a:ea typeface="Times New Roman" panose="02020603050405020304" pitchFamily="18" charset="0"/>
                <a:cs typeface="Times New Roman" panose="02020603050405020304" pitchFamily="18" charset="0"/>
              </a:rPr>
              <a:t>LWBQ01000008  992338  </a:t>
            </a: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--------------------------------------------------------------------</a:t>
            </a:r>
            <a:endParaRPr lang="en-US" sz="34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</a:pP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GT2  MG770309   1</a:t>
            </a:r>
            <a:endParaRPr lang="en-US" sz="34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</a:pP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GT3  HM595984   518</a:t>
            </a:r>
            <a:endParaRPr lang="en-US" sz="34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</a:pP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GT4  AB067744   596   ---------</a:t>
            </a:r>
            <a:endParaRPr lang="en-US" sz="34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</a:pP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GT5  AB067740   600   -----------------T--T----------TT-------------A------T--T----T------AAAATCTAGCCCCCCTACG</a:t>
            </a:r>
            <a:endParaRPr lang="en-US" sz="34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</a:pP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GT6  EU555436   467</a:t>
            </a:r>
            <a:endParaRPr lang="en-US" sz="34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</a:pP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GT15 KT232017   577   ---------</a:t>
            </a:r>
            <a:endParaRPr lang="en-US" sz="34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</a:pP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GT16 KT232019   577   ---------</a:t>
            </a:r>
            <a:endParaRPr lang="en-US" sz="3400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</a:pPr>
            <a:r>
              <a:rPr lang="en-US" sz="3400" b="1" dirty="0">
                <a:latin typeface="Courier New" panose="02070309020205020404" pitchFamily="49" charset="0"/>
                <a:ea typeface="SimSun" panose="02010600030101010101" pitchFamily="2" charset="-122"/>
                <a:cs typeface="Times New Roman" panose="02020603050405020304" pitchFamily="18" charset="0"/>
              </a:rPr>
              <a:t>GT17 KT232010   577   ---------</a:t>
            </a:r>
            <a:endParaRPr lang="en-US" sz="3400" dirty="0"/>
          </a:p>
        </p:txBody>
      </p:sp>
    </p:spTree>
    <p:extLst>
      <p:ext uri="{BB962C8B-B14F-4D97-AF65-F5344CB8AC3E}">
        <p14:creationId xmlns:p14="http://schemas.microsoft.com/office/powerpoint/2010/main" val="28884074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535</TotalTime>
  <Words>1075</Words>
  <Application>Microsoft Office PowerPoint</Application>
  <PresentationFormat>Custom</PresentationFormat>
  <Paragraphs>10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Courier New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uadmin</dc:creator>
  <cp:lastModifiedBy>Jiashi Zhu</cp:lastModifiedBy>
  <cp:revision>108</cp:revision>
  <dcterms:created xsi:type="dcterms:W3CDTF">2014-11-22T20:28:47Z</dcterms:created>
  <dcterms:modified xsi:type="dcterms:W3CDTF">2023-02-16T22:04:25Z</dcterms:modified>
</cp:coreProperties>
</file>